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1" d="100"/>
          <a:sy n="71" d="100"/>
        </p:scale>
        <p:origin x="48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A6410-0DEA-46F2-AE0C-0DAFC19F0267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C1D9F-60AA-4DD5-9F52-3EBEFD924A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600435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A6410-0DEA-46F2-AE0C-0DAFC19F0267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C1D9F-60AA-4DD5-9F52-3EBEFD924A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826551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A6410-0DEA-46F2-AE0C-0DAFC19F0267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C1D9F-60AA-4DD5-9F52-3EBEFD924A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02303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A6410-0DEA-46F2-AE0C-0DAFC19F0267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C1D9F-60AA-4DD5-9F52-3EBEFD924A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89253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A6410-0DEA-46F2-AE0C-0DAFC19F0267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C1D9F-60AA-4DD5-9F52-3EBEFD924A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71902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A6410-0DEA-46F2-AE0C-0DAFC19F0267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C1D9F-60AA-4DD5-9F52-3EBEFD924A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043021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A6410-0DEA-46F2-AE0C-0DAFC19F0267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C1D9F-60AA-4DD5-9F52-3EBEFD924A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65968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A6410-0DEA-46F2-AE0C-0DAFC19F0267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C1D9F-60AA-4DD5-9F52-3EBEFD924A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793382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A6410-0DEA-46F2-AE0C-0DAFC19F0267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C1D9F-60AA-4DD5-9F52-3EBEFD924A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77248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A6410-0DEA-46F2-AE0C-0DAFC19F0267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C1D9F-60AA-4DD5-9F52-3EBEFD924A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934061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A6410-0DEA-46F2-AE0C-0DAFC19F0267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C1D9F-60AA-4DD5-9F52-3EBEFD924A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918085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CA6410-0DEA-46F2-AE0C-0DAFC19F0267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5C1D9F-60AA-4DD5-9F52-3EBEFD924A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370108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4" Type="http://schemas.microsoft.com/office/2007/relationships/hdphoto" Target="../media/hdphoto1.wdp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4" Type="http://schemas.microsoft.com/office/2007/relationships/hdphoto" Target="../media/hdphoto2.wdp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2"/>
          <a:srcRect t="20834" b="16666"/>
          <a:stretch/>
        </p:blipFill>
        <p:spPr>
          <a:xfrm>
            <a:off x="2891117" y="3039034"/>
            <a:ext cx="2151530" cy="60511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图片 6"/>
          <p:cNvPicPr>
            <a:picLocks noChangeAspect="1"/>
          </p:cNvPicPr>
          <p:nvPr/>
        </p:nvPicPr>
        <p:blipFill rotWithShape="1">
          <a:blip r:embed="rId3"/>
          <a:srcRect t="36581"/>
          <a:stretch/>
        </p:blipFill>
        <p:spPr>
          <a:xfrm>
            <a:off x="2891117" y="3697943"/>
            <a:ext cx="2151530" cy="63438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891117" y="4383737"/>
            <a:ext cx="2151530" cy="83372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" name="文本框 9"/>
          <p:cNvSpPr txBox="1"/>
          <p:nvPr/>
        </p:nvSpPr>
        <p:spPr>
          <a:xfrm>
            <a:off x="5042647" y="3170837"/>
            <a:ext cx="177163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FLAG (Input)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5087471" y="3793882"/>
            <a:ext cx="21018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nti-FLAG (FLAG IP)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5118848" y="4605185"/>
            <a:ext cx="213552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nti-EGFR (FLAG IP)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4" name="矩形 13"/>
          <p:cNvSpPr/>
          <p:nvPr/>
        </p:nvSpPr>
        <p:spPr>
          <a:xfrm>
            <a:off x="2778717" y="2085374"/>
            <a:ext cx="212109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HeLa: APEX2-FLAG-</a:t>
            </a:r>
            <a:endParaRPr lang="zh-CN" altLang="en-US" sz="1600" dirty="0"/>
          </a:p>
        </p:txBody>
      </p:sp>
      <p:sp>
        <p:nvSpPr>
          <p:cNvPr id="15" name="文本框 14"/>
          <p:cNvSpPr txBox="1"/>
          <p:nvPr/>
        </p:nvSpPr>
        <p:spPr>
          <a:xfrm>
            <a:off x="3126442" y="2420474"/>
            <a:ext cx="69602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TS1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2525261" y="2720657"/>
            <a:ext cx="6062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EGF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3161753" y="2738587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3636881" y="2743070"/>
            <a:ext cx="3048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4018427" y="2398063"/>
            <a:ext cx="85632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W295A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4188208" y="2743070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4636442" y="2747553"/>
            <a:ext cx="3048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2" name="直接连接符 21"/>
          <p:cNvCxnSpPr/>
          <p:nvPr/>
        </p:nvCxnSpPr>
        <p:spPr>
          <a:xfrm>
            <a:off x="3124038" y="2772476"/>
            <a:ext cx="64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" name="直接连接符 22"/>
          <p:cNvCxnSpPr/>
          <p:nvPr/>
        </p:nvCxnSpPr>
        <p:spPr>
          <a:xfrm>
            <a:off x="4137046" y="2763512"/>
            <a:ext cx="72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文本框 23"/>
          <p:cNvSpPr txBox="1"/>
          <p:nvPr/>
        </p:nvSpPr>
        <p:spPr>
          <a:xfrm>
            <a:off x="329091" y="428265"/>
            <a:ext cx="39805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ementary figure 8e. Replicate 1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2256440" y="3237609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0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5" name="直接连接符 24"/>
          <p:cNvCxnSpPr/>
          <p:nvPr/>
        </p:nvCxnSpPr>
        <p:spPr>
          <a:xfrm>
            <a:off x="2725111" y="3382074"/>
            <a:ext cx="1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文本框 25"/>
          <p:cNvSpPr txBox="1"/>
          <p:nvPr/>
        </p:nvSpPr>
        <p:spPr>
          <a:xfrm>
            <a:off x="2234029" y="3900995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0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7" name="直接连接符 26"/>
          <p:cNvCxnSpPr/>
          <p:nvPr/>
        </p:nvCxnSpPr>
        <p:spPr>
          <a:xfrm>
            <a:off x="2702700" y="4045460"/>
            <a:ext cx="1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文本框 27"/>
          <p:cNvSpPr txBox="1"/>
          <p:nvPr/>
        </p:nvSpPr>
        <p:spPr>
          <a:xfrm>
            <a:off x="2251959" y="4577828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8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9" name="直接连接符 28"/>
          <p:cNvCxnSpPr/>
          <p:nvPr/>
        </p:nvCxnSpPr>
        <p:spPr>
          <a:xfrm>
            <a:off x="2720630" y="4722293"/>
            <a:ext cx="1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文本框 29"/>
          <p:cNvSpPr txBox="1"/>
          <p:nvPr/>
        </p:nvSpPr>
        <p:spPr>
          <a:xfrm>
            <a:off x="2242995" y="4784016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3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31" name="直接连接符 30"/>
          <p:cNvCxnSpPr/>
          <p:nvPr/>
        </p:nvCxnSpPr>
        <p:spPr>
          <a:xfrm>
            <a:off x="2711666" y="4928481"/>
            <a:ext cx="1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7715955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329091" y="428265"/>
            <a:ext cx="39805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ementary figure 8e. Replicate 2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63316" y="3120837"/>
            <a:ext cx="2958633" cy="43223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文本框 3"/>
          <p:cNvSpPr txBox="1"/>
          <p:nvPr/>
        </p:nvSpPr>
        <p:spPr>
          <a:xfrm>
            <a:off x="2524110" y="2470894"/>
            <a:ext cx="6335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TS1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2030505" y="2773317"/>
            <a:ext cx="5533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EGF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2559421" y="2791247"/>
            <a:ext cx="243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2900079" y="2795730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3214390" y="2470894"/>
            <a:ext cx="7729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W295A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3276595" y="2795730"/>
            <a:ext cx="243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3617253" y="2800213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11" name="直接连接符 10"/>
          <p:cNvCxnSpPr/>
          <p:nvPr/>
        </p:nvCxnSpPr>
        <p:spPr>
          <a:xfrm>
            <a:off x="2575494" y="2843066"/>
            <a:ext cx="54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直接连接符 11"/>
          <p:cNvCxnSpPr/>
          <p:nvPr/>
        </p:nvCxnSpPr>
        <p:spPr>
          <a:xfrm>
            <a:off x="3319562" y="2843066"/>
            <a:ext cx="54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文本框 12"/>
          <p:cNvSpPr txBox="1"/>
          <p:nvPr/>
        </p:nvSpPr>
        <p:spPr>
          <a:xfrm>
            <a:off x="3953975" y="2470894"/>
            <a:ext cx="6335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TS1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3989286" y="2809177"/>
            <a:ext cx="243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4329944" y="2813660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4644255" y="2470894"/>
            <a:ext cx="7729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W295A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4706460" y="2813660"/>
            <a:ext cx="243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5047118" y="2818143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19" name="直接连接符 18"/>
          <p:cNvCxnSpPr/>
          <p:nvPr/>
        </p:nvCxnSpPr>
        <p:spPr>
          <a:xfrm>
            <a:off x="4005359" y="2843066"/>
            <a:ext cx="54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直接连接符 19"/>
          <p:cNvCxnSpPr/>
          <p:nvPr/>
        </p:nvCxnSpPr>
        <p:spPr>
          <a:xfrm>
            <a:off x="4749427" y="2843066"/>
            <a:ext cx="54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文本框 20"/>
          <p:cNvSpPr txBox="1"/>
          <p:nvPr/>
        </p:nvSpPr>
        <p:spPr>
          <a:xfrm>
            <a:off x="2871988" y="2062246"/>
            <a:ext cx="6415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Input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4099826" y="2083711"/>
            <a:ext cx="9717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FLAG IP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3" name="直接连接符 22"/>
          <p:cNvCxnSpPr/>
          <p:nvPr/>
        </p:nvCxnSpPr>
        <p:spPr>
          <a:xfrm>
            <a:off x="2705483" y="2430692"/>
            <a:ext cx="10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直接连接符 23"/>
          <p:cNvCxnSpPr/>
          <p:nvPr/>
        </p:nvCxnSpPr>
        <p:spPr>
          <a:xfrm>
            <a:off x="4108454" y="2435175"/>
            <a:ext cx="10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文本框 24"/>
          <p:cNvSpPr txBox="1"/>
          <p:nvPr/>
        </p:nvSpPr>
        <p:spPr>
          <a:xfrm>
            <a:off x="5417224" y="3184189"/>
            <a:ext cx="10214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FLAG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5435154" y="3820681"/>
            <a:ext cx="10518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EGFR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53" name="图片 52"/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0059" t="36460" r="25599" b="43725"/>
          <a:stretch/>
        </p:blipFill>
        <p:spPr>
          <a:xfrm>
            <a:off x="2458869" y="3640530"/>
            <a:ext cx="2960295" cy="80682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8" name="文本框 27"/>
          <p:cNvSpPr txBox="1"/>
          <p:nvPr/>
        </p:nvSpPr>
        <p:spPr>
          <a:xfrm>
            <a:off x="1817172" y="3295880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0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9" name="直接连接符 28"/>
          <p:cNvCxnSpPr/>
          <p:nvPr/>
        </p:nvCxnSpPr>
        <p:spPr>
          <a:xfrm>
            <a:off x="2285843" y="3440345"/>
            <a:ext cx="1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文本框 29"/>
          <p:cNvSpPr txBox="1"/>
          <p:nvPr/>
        </p:nvSpPr>
        <p:spPr>
          <a:xfrm>
            <a:off x="1835102" y="3986160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8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31" name="直接连接符 30"/>
          <p:cNvCxnSpPr/>
          <p:nvPr/>
        </p:nvCxnSpPr>
        <p:spPr>
          <a:xfrm>
            <a:off x="2303773" y="4130625"/>
            <a:ext cx="1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文本框 31"/>
          <p:cNvSpPr txBox="1"/>
          <p:nvPr/>
        </p:nvSpPr>
        <p:spPr>
          <a:xfrm>
            <a:off x="1826138" y="4192348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3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33" name="直接连接符 32"/>
          <p:cNvCxnSpPr/>
          <p:nvPr/>
        </p:nvCxnSpPr>
        <p:spPr>
          <a:xfrm>
            <a:off x="2294809" y="4336813"/>
            <a:ext cx="1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6806525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329091" y="428265"/>
            <a:ext cx="39805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ementary figure 8e. Replicate 3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31911" y="3114211"/>
            <a:ext cx="2942397" cy="48051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文本框 4"/>
          <p:cNvSpPr txBox="1"/>
          <p:nvPr/>
        </p:nvSpPr>
        <p:spPr>
          <a:xfrm>
            <a:off x="5803744" y="3190412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</a:t>
            </a:r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nti-FLAG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5821674" y="4042056"/>
            <a:ext cx="10310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</a:t>
            </a:r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nti-EGFR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2846494" y="2475376"/>
            <a:ext cx="6335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TS1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2352889" y="2777799"/>
            <a:ext cx="5533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EGF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2881805" y="2795729"/>
            <a:ext cx="243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3222463" y="2800212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3536774" y="2475376"/>
            <a:ext cx="7729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W295A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3598979" y="2800212"/>
            <a:ext cx="243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3939637" y="2804695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14" name="直接连接符 13"/>
          <p:cNvCxnSpPr/>
          <p:nvPr/>
        </p:nvCxnSpPr>
        <p:spPr>
          <a:xfrm>
            <a:off x="2897878" y="2847548"/>
            <a:ext cx="54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直接连接符 14"/>
          <p:cNvCxnSpPr/>
          <p:nvPr/>
        </p:nvCxnSpPr>
        <p:spPr>
          <a:xfrm>
            <a:off x="3641946" y="2847548"/>
            <a:ext cx="54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文本框 15"/>
          <p:cNvSpPr txBox="1"/>
          <p:nvPr/>
        </p:nvSpPr>
        <p:spPr>
          <a:xfrm>
            <a:off x="4437723" y="2475376"/>
            <a:ext cx="6335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TS1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4473034" y="2813659"/>
            <a:ext cx="243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4813692" y="2818142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5128003" y="2475376"/>
            <a:ext cx="7729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W295A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5190208" y="2818142"/>
            <a:ext cx="243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5530866" y="2822625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2" name="直接连接符 21"/>
          <p:cNvCxnSpPr/>
          <p:nvPr/>
        </p:nvCxnSpPr>
        <p:spPr>
          <a:xfrm>
            <a:off x="4489107" y="2847548"/>
            <a:ext cx="54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" name="直接连接符 22"/>
          <p:cNvCxnSpPr/>
          <p:nvPr/>
        </p:nvCxnSpPr>
        <p:spPr>
          <a:xfrm>
            <a:off x="5233175" y="2847548"/>
            <a:ext cx="54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文本框 23"/>
          <p:cNvSpPr txBox="1"/>
          <p:nvPr/>
        </p:nvSpPr>
        <p:spPr>
          <a:xfrm>
            <a:off x="3194372" y="2066728"/>
            <a:ext cx="6415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Input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4583574" y="2088193"/>
            <a:ext cx="9717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FLAG IP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6" name="直接连接符 25"/>
          <p:cNvCxnSpPr/>
          <p:nvPr/>
        </p:nvCxnSpPr>
        <p:spPr>
          <a:xfrm>
            <a:off x="3027867" y="2435174"/>
            <a:ext cx="10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直接连接符 26"/>
          <p:cNvCxnSpPr/>
          <p:nvPr/>
        </p:nvCxnSpPr>
        <p:spPr>
          <a:xfrm>
            <a:off x="4592202" y="2439657"/>
            <a:ext cx="10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28" name="图片 27"/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7378" t="27931" r="9932" b="47094"/>
          <a:stretch/>
        </p:blipFill>
        <p:spPr>
          <a:xfrm>
            <a:off x="2832714" y="3670448"/>
            <a:ext cx="2953908" cy="94129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9" name="文本框 28"/>
          <p:cNvSpPr txBox="1"/>
          <p:nvPr/>
        </p:nvSpPr>
        <p:spPr>
          <a:xfrm>
            <a:off x="2188860" y="3322773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0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30" name="直接连接符 29"/>
          <p:cNvCxnSpPr/>
          <p:nvPr/>
        </p:nvCxnSpPr>
        <p:spPr>
          <a:xfrm>
            <a:off x="2657531" y="3467238"/>
            <a:ext cx="1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" name="文本框 30"/>
          <p:cNvSpPr txBox="1"/>
          <p:nvPr/>
        </p:nvSpPr>
        <p:spPr>
          <a:xfrm>
            <a:off x="2206790" y="4120629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8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32" name="直接连接符 31"/>
          <p:cNvCxnSpPr/>
          <p:nvPr/>
        </p:nvCxnSpPr>
        <p:spPr>
          <a:xfrm>
            <a:off x="2675461" y="4265094"/>
            <a:ext cx="1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" name="文本框 32"/>
          <p:cNvSpPr txBox="1"/>
          <p:nvPr/>
        </p:nvSpPr>
        <p:spPr>
          <a:xfrm>
            <a:off x="2197826" y="4326817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3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34" name="直接连接符 33"/>
          <p:cNvCxnSpPr/>
          <p:nvPr/>
        </p:nvCxnSpPr>
        <p:spPr>
          <a:xfrm>
            <a:off x="2666497" y="4471282"/>
            <a:ext cx="1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96776075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698"/>
          <a:stretch/>
        </p:blipFill>
        <p:spPr>
          <a:xfrm>
            <a:off x="2017059" y="1892807"/>
            <a:ext cx="3809655" cy="3082604"/>
          </a:xfrm>
          <a:prstGeom prst="rect">
            <a:avLst/>
          </a:prstGeom>
        </p:spPr>
      </p:pic>
      <p:sp>
        <p:nvSpPr>
          <p:cNvPr id="4" name="矩形 3"/>
          <p:cNvSpPr/>
          <p:nvPr/>
        </p:nvSpPr>
        <p:spPr>
          <a:xfrm>
            <a:off x="0" y="959414"/>
            <a:ext cx="559397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ementary figure 8e. Quantification (n=3)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6581757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</TotalTime>
  <Words>96</Words>
  <Application>Microsoft Office PowerPoint</Application>
  <PresentationFormat>全屏显示(4:3)</PresentationFormat>
  <Paragraphs>59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0" baseType="lpstr">
      <vt:lpstr>Arial Unicode MS</vt:lpstr>
      <vt:lpstr>宋体</vt:lpstr>
      <vt:lpstr>Arial</vt:lpstr>
      <vt:lpstr>Calibri</vt:lpstr>
      <vt:lpstr>Calibri Light</vt:lpstr>
      <vt:lpstr>Office 主题</vt:lpstr>
      <vt:lpstr>PowerPoint 演示文稿</vt:lpstr>
      <vt:lpstr>PowerPoint 演示文稿</vt:lpstr>
      <vt:lpstr>PowerPoint 演示文稿</vt:lpstr>
      <vt:lpstr>PowerPoint 演示文稿</vt:lpstr>
    </vt:vector>
  </TitlesOfParts>
  <Company>SUST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dows 用户</dc:creator>
  <cp:lastModifiedBy>Windows 用户</cp:lastModifiedBy>
  <cp:revision>9</cp:revision>
  <dcterms:created xsi:type="dcterms:W3CDTF">2020-08-31T12:34:59Z</dcterms:created>
  <dcterms:modified xsi:type="dcterms:W3CDTF">2020-10-12T07:42:16Z</dcterms:modified>
</cp:coreProperties>
</file>